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14075449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 snapToObjects="1" showGuides="1">
      <p:cViewPr varScale="1">
        <p:scale>
          <a:sx n="128" d="100"/>
          <a:sy n="128" d="100"/>
        </p:scale>
        <p:origin x="480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98B368-F1B3-0245-95A4-8A5768AB854F}" type="datetimeFigureOut">
              <a:rPr lang="en-US" smtClean="0"/>
              <a:t>6/27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654732-3731-D34B-A754-A38BD1D213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127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6D4B4D-86AA-2D8B-49C9-B9730EB40A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632E16B-998E-C07C-46DF-A2A359F9AA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FAAD85-AB7F-2BD5-CC76-8617642D9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4144AE-C7EF-A1B1-3DF8-AC3A3EC46C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874B88-59EE-7ACE-EE58-CFDE8A40A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412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646BCD-3DA5-7EA2-1E41-C25DCA4AA4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0D5E7B-83C0-A78B-1F0E-DDE0115054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BF3E42-D991-C08A-8527-15E816CAF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2D6FCB-A00A-E1AD-70BB-07A34490D2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5AEB75-EB08-C39D-B1CF-63C8704061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073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CD7C3C5-71C0-A1B2-9F1F-887D392FD7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8EE4FF-0CB6-7D57-F380-770CED4ED5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BCBFCF-8EBD-F4B4-2D80-0B4ECE8FA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494CF6-5D71-408F-63AF-14742B78C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02F832-B7F9-D4D6-70EB-D52EED4B8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36273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7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06B85D-899C-944F-A2E0-4894DCE922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Subtitle 2">
            <a:extLst>
              <a:ext uri="{FF2B5EF4-FFF2-40B4-BE49-F238E27FC236}">
                <a16:creationId xmlns:a16="http://schemas.microsoft.com/office/drawing/2014/main" id="{E28CA5FF-AACC-4AB7-B6E7-D6A63EA944DB}"/>
              </a:ext>
            </a:extLst>
          </p:cNvPr>
          <p:cNvSpPr>
            <a:spLocks noGrp="1"/>
          </p:cNvSpPr>
          <p:nvPr>
            <p:ph type="subTitle" idx="10" hasCustomPrompt="1"/>
          </p:nvPr>
        </p:nvSpPr>
        <p:spPr>
          <a:xfrm>
            <a:off x="614853" y="1161597"/>
            <a:ext cx="10962290" cy="276999"/>
          </a:xfrm>
        </p:spPr>
        <p:txBody>
          <a:bodyPr wrap="square">
            <a:spAutoFit/>
          </a:bodyPr>
          <a:lstStyle>
            <a:lvl1pPr marL="0" indent="0" algn="l">
              <a:buNone/>
              <a:defRPr sz="2000" b="0" i="0" baseline="0">
                <a:solidFill>
                  <a:schemeClr val="accent3"/>
                </a:solidFill>
                <a:latin typeface="+mn-lt"/>
                <a:cs typeface="Gotham Bold" pitchFamily="2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subtitle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EDEDEA15-1C46-42C0-9541-5C897D1A89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6" name="Footnotes">
            <a:extLst>
              <a:ext uri="{FF2B5EF4-FFF2-40B4-BE49-F238E27FC236}">
                <a16:creationId xmlns:a16="http://schemas.microsoft.com/office/drawing/2014/main" id="{38ABFE29-F12E-4908-BBBE-F167F72BD474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614854" y="6019800"/>
            <a:ext cx="9139237" cy="352572"/>
          </a:xfrm>
        </p:spPr>
        <p:txBody>
          <a:bodyPr anchor="b">
            <a:noAutofit/>
          </a:bodyPr>
          <a:lstStyle>
            <a:lvl1pPr marL="115888" indent="-115888">
              <a:spcBef>
                <a:spcPts val="300"/>
              </a:spcBef>
              <a:spcAft>
                <a:spcPts val="0"/>
              </a:spcAft>
              <a:buFont typeface="+mj-lt"/>
              <a:buAutoNum type="arabicPeriod"/>
              <a:defRPr sz="800">
                <a:solidFill>
                  <a:schemeClr val="tx2"/>
                </a:solidFill>
                <a:latin typeface="+mn-lt"/>
              </a:defRPr>
            </a:lvl1pPr>
            <a:lvl2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2pPr>
            <a:lvl3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3pPr>
            <a:lvl4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4pPr>
            <a:lvl5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5pPr>
            <a:lvl6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6pPr>
            <a:lvl7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7pPr>
            <a:lvl8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8pPr>
            <a:lvl9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9pPr>
          </a:lstStyle>
          <a:p>
            <a:pPr lvl="0"/>
            <a:r>
              <a:rPr lang="en-US"/>
              <a:t>Click to add a reference</a:t>
            </a:r>
          </a:p>
        </p:txBody>
      </p:sp>
    </p:spTree>
    <p:extLst>
      <p:ext uri="{BB962C8B-B14F-4D97-AF65-F5344CB8AC3E}">
        <p14:creationId xmlns:p14="http://schemas.microsoft.com/office/powerpoint/2010/main" val="934693454"/>
      </p:ext>
    </p:extLst>
  </p:cSld>
  <p:clrMapOvr>
    <a:masterClrMapping/>
  </p:clrMapOvr>
  <p:transition spd="med">
    <p:fade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1E4477-E2C6-333E-7719-D0110A0908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211F44-6541-C656-9423-672E6D4C77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29360A-D345-B9A3-98F9-2562CCC59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E9D474-E09B-F229-AB05-E741B9383A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D80891-93F2-2BDA-12FD-391EF77104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752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D10A86-25F3-EC62-2093-A0ACF40761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8D1118-8BAB-76B5-FEC7-9E984780E6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6786A5-6961-99B3-B7EB-B08C9FB7A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D05593-D3B5-A46B-1E20-3B42FE3BD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DAF183-D6B4-F12F-D3B6-BE3728054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173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D50339-6B24-28B7-6731-6F50E65F6F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FF5F1F-0CC3-D379-35E9-AD524FCE35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5D30D2-22CF-A94E-163A-05B2B4A6BD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0F88EA-B300-6990-1E88-45239B258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AA1BEC-C618-848F-79D7-BA954C8898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31C6AC-69F2-5A13-03C3-3AD481CA91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68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627115-C71D-868B-9F4C-036DB1422F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B570CC-37EC-5849-B1AE-CF42709C63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23A815-562C-CA29-DF83-E3B05239E1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3DA066F-F142-A310-FBC5-11C5467C2E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98045C0-914C-67C6-2AB6-E07E6944A4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3214B8-9017-1262-AFAC-B7D33BC338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F9F62EE-DAB4-B597-8FFF-B358848CD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D738EFA-0729-2895-CC19-0D8A1CE2B7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9370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D62CF3-AE73-DB7D-1832-42A183991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F82E599-7E90-14DC-69BE-FE02C24707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B84F30C-C766-9DF0-2F92-574037DD09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2463212-7AB9-4CCE-05AE-4AC30D8979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8725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50F5844-E514-2665-0563-A742A46D5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1C0F884-2473-FEBA-C949-15C20EB5D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66191E0-7615-C448-3E88-96FC4E4BF0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06507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EBBDE2-AC71-BB30-926A-AC6C84A77F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5F1FCB-4A60-EECB-216B-78FED4CE6C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9111C4-7F35-030A-B351-BEFC9876DA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BAEC91-AA23-18EF-976F-CE19C3A6DA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BE547F-263A-36B2-F6EC-F1692140A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33B1D8-A907-D8BE-F3BD-5A81D708A5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6051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2FE9E7-0B82-593B-427F-E268B23E06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7019921-432F-E8A3-FE40-2108DAC74A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D1C407-FD24-64F3-FB38-C90E252D59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4FE28B-DC92-0E6F-6691-8FB68A8A86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0E5EB2-A374-0635-223E-B497A5280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5BC3EB-9B62-4587-EC39-B7B1EB86B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0090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F579E1B-4AD0-A052-060E-38E99E5F92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AE9465-F527-A2C4-C944-745A6C335A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C55A13-8B0A-9713-675C-36D57B45C1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BA2CC6-F9B3-0E4C-8F18-E150A4FE5CD5}" type="datetimeFigureOut">
              <a:rPr lang="en-US" smtClean="0"/>
              <a:t>6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D0A70C-5E4E-D09F-3996-A0A001D4F9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C7EC20-85C0-BCBD-ABF8-AA0F691DAD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839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ontent Placeholder 1">
            <a:extLst>
              <a:ext uri="{FF2B5EF4-FFF2-40B4-BE49-F238E27FC236}">
                <a16:creationId xmlns:a16="http://schemas.microsoft.com/office/drawing/2014/main" id="{18F39F3C-F56B-9640-B152-EB6E98BDE8A8}"/>
              </a:ext>
            </a:extLst>
          </p:cNvPr>
          <p:cNvSpPr txBox="1">
            <a:spLocks/>
          </p:cNvSpPr>
          <p:nvPr/>
        </p:nvSpPr>
        <p:spPr>
          <a:xfrm>
            <a:off x="429539" y="1063571"/>
            <a:ext cx="4027498" cy="1626684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>
            <a:lvl1pPr marL="0" indent="6350" algn="l" defTabSz="914400" rtl="0" eaLnBrk="1" latinLnBrk="0" hangingPunct="1">
              <a:lnSpc>
                <a:spcPct val="90000"/>
              </a:lnSpc>
              <a:spcBef>
                <a:spcPts val="1000"/>
              </a:spcBef>
              <a:spcAft>
                <a:spcPts val="600"/>
              </a:spcAft>
              <a:buFont typeface="Arial" panose="020B0604020202020204" pitchFamily="34" charset="0"/>
              <a:buChar char="​"/>
              <a:defRPr sz="2000" kern="1200">
                <a:solidFill>
                  <a:schemeClr val="tx1"/>
                </a:solidFill>
                <a:latin typeface="Gotham Bold" pitchFamily="50" charset="0"/>
                <a:ea typeface="+mn-ea"/>
                <a:cs typeface="Gotham Bold" pitchFamily="50" charset="0"/>
              </a:defRPr>
            </a:lvl1pPr>
            <a:lvl2pPr marL="1714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3"/>
              </a:buClr>
              <a:buSzPct val="100000"/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2pPr>
            <a:lvl3pPr marL="4000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3pPr>
            <a:lvl4pPr marL="6286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4pPr>
            <a:lvl5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5pPr>
            <a:lvl6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6pPr>
            <a:lvl7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7pPr>
            <a:lvl8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8pPr>
            <a:lvl9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T Sectra Book" panose="02000503070000020003" pitchFamily="50" charset="0"/>
              <a:buChar char="“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9pPr>
          </a:lstStyle>
          <a:p>
            <a:pPr indent="0">
              <a:buNone/>
            </a:pPr>
            <a:r>
              <a:rPr lang="en-US" sz="1400" b="1" dirty="0">
                <a:latin typeface="Calibri" panose="020F0502020204030204" pitchFamily="34" charset="0"/>
                <a:cs typeface="Calibri" panose="020F0502020204030204" pitchFamily="34" charset="0"/>
              </a:rPr>
              <a:t>Supplemental Table S6. </a:t>
            </a:r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Summary of TMB ranges per cohort and PD-L1. The median and interquartile range of TMB is shown per group within the cohorts, grouped by PD-L1 status.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0B40A81E-F118-A347-A0E5-B5F6B4B534A3}"/>
              </a:ext>
            </a:extLst>
          </p:cNvPr>
          <p:cNvGraphicFramePr>
            <a:graphicFrameLocks noGrp="1"/>
          </p:cNvGraphicFramePr>
          <p:nvPr/>
        </p:nvGraphicFramePr>
        <p:xfrm>
          <a:off x="6874280" y="1064655"/>
          <a:ext cx="3328515" cy="3251200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827028">
                  <a:extLst>
                    <a:ext uri="{9D8B030D-6E8A-4147-A177-3AD203B41FA5}">
                      <a16:colId xmlns:a16="http://schemas.microsoft.com/office/drawing/2014/main" val="769584978"/>
                    </a:ext>
                  </a:extLst>
                </a:gridCol>
                <a:gridCol w="827028">
                  <a:extLst>
                    <a:ext uri="{9D8B030D-6E8A-4147-A177-3AD203B41FA5}">
                      <a16:colId xmlns:a16="http://schemas.microsoft.com/office/drawing/2014/main" val="1827903683"/>
                    </a:ext>
                  </a:extLst>
                </a:gridCol>
                <a:gridCol w="405972">
                  <a:extLst>
                    <a:ext uri="{9D8B030D-6E8A-4147-A177-3AD203B41FA5}">
                      <a16:colId xmlns:a16="http://schemas.microsoft.com/office/drawing/2014/main" val="4170357718"/>
                    </a:ext>
                  </a:extLst>
                </a:gridCol>
                <a:gridCol w="1268487">
                  <a:extLst>
                    <a:ext uri="{9D8B030D-6E8A-4147-A177-3AD203B41FA5}">
                      <a16:colId xmlns:a16="http://schemas.microsoft.com/office/drawing/2014/main" val="3449530809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ohor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PDL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Median TMB (IQR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0518870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1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PS 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7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3.8 (1.6 - 6.3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2390189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1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PS 1-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0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3.8 (1.7 - 5.2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422178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1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PS 10+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1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3.8 (2.5 - 6.3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7865996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1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PS 5-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6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3.8 (2.5 - 6.3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7044700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1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unknow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34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3.8 (1.7 - 6.3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836296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2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CPS 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4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3.2 (1.4 - 5.2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4206091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2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PS 1-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4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4.3 (1.7 - 6.3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4044178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2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PS 10+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6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3.8 (2.5 - 6.4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1235913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2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PS 5-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3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3.8 (1.9 - 6.3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7595695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2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unknow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7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3.8 (1.7 - 7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1630733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eq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PS 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3.8 (2.5 - 5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1175908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eq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PS 1-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2.5 (1.4 - 5.2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9295761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eq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PS 10+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4.7 (2.8 - 9.6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380162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eq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PS 5-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6.3 (5.6 - 11.6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4062586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Seq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unknow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2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3.8 (2.6 - 21.7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3410082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77910791"/>
      </p:ext>
    </p:extLst>
  </p:cSld>
  <p:clrMapOvr>
    <a:masterClrMapping/>
  </p:clrMapOvr>
  <p:transition spd="med">
    <p:fade/>
  </p:transition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191</Words>
  <Application>Microsoft Macintosh PowerPoint</Application>
  <PresentationFormat>Widescreen</PresentationFormat>
  <Paragraphs>6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Tables &amp; Figures</dc:title>
  <dc:creator>Klempner, Samuel J.,MD</dc:creator>
  <cp:lastModifiedBy>Klempner, Samuel J.,MD</cp:lastModifiedBy>
  <cp:revision>8</cp:revision>
  <dcterms:created xsi:type="dcterms:W3CDTF">2022-06-12T16:24:02Z</dcterms:created>
  <dcterms:modified xsi:type="dcterms:W3CDTF">2022-06-27T19:55:56Z</dcterms:modified>
</cp:coreProperties>
</file>